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ik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4615"/>
  </p:normalViewPr>
  <p:slideViewPr>
    <p:cSldViewPr snapToGrid="0" snapToObjects="1">
      <p:cViewPr varScale="1">
        <p:scale>
          <a:sx n="65" d="100"/>
          <a:sy n="65" d="100"/>
        </p:scale>
        <p:origin x="41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83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356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925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01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059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09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858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966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52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806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047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A4FA6-4FFF-1947-87EF-D6C0DEFC142B}" type="datetimeFigureOut">
              <a:rPr lang="en-US" smtClean="0"/>
              <a:t>1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579A71-17D9-5644-8EE8-0609F4CF3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218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vik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29" t="14647" r="17086"/>
          <a:stretch/>
        </p:blipFill>
        <p:spPr>
          <a:xfrm>
            <a:off x="3979247" y="2021358"/>
            <a:ext cx="6250138" cy="465028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 flipH="1" flipV="1">
            <a:off x="6606971" y="-987046"/>
            <a:ext cx="489465" cy="5527342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71" r="23187" b="89152"/>
          <a:stretch/>
        </p:blipFill>
        <p:spPr>
          <a:xfrm>
            <a:off x="4019003" y="927616"/>
            <a:ext cx="5665006" cy="59102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617066" y="171398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Z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374323" y="1713987"/>
            <a:ext cx="433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R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131366" y="1713987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228743" y="1713987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787816" y="1713987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RZ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336485" y="1713987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Q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624418" y="1713987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X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9676643" y="2681553"/>
            <a:ext cx="401336" cy="2072640"/>
          </a:xfrm>
          <a:prstGeom prst="rect">
            <a:avLst/>
          </a:prstGeom>
          <a:solidFill>
            <a:schemeClr val="accent1">
              <a:lumMod val="40000"/>
              <a:lumOff val="60000"/>
              <a:alpha val="2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9676643" y="4845633"/>
            <a:ext cx="401336" cy="398025"/>
          </a:xfrm>
          <a:prstGeom prst="rect">
            <a:avLst/>
          </a:prstGeom>
          <a:solidFill>
            <a:schemeClr val="accent1">
              <a:lumMod val="40000"/>
              <a:lumOff val="60000"/>
              <a:alpha val="2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9676642" y="5326390"/>
            <a:ext cx="420501" cy="960511"/>
          </a:xfrm>
          <a:prstGeom prst="rect">
            <a:avLst/>
          </a:prstGeom>
          <a:solidFill>
            <a:schemeClr val="accent1">
              <a:lumMod val="40000"/>
              <a:lumOff val="60000"/>
              <a:alpha val="2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9684008" y="2402878"/>
            <a:ext cx="393971" cy="174215"/>
          </a:xfrm>
          <a:prstGeom prst="rect">
            <a:avLst/>
          </a:prstGeom>
          <a:solidFill>
            <a:schemeClr val="accent1">
              <a:lumMod val="40000"/>
              <a:lumOff val="60000"/>
              <a:alpha val="2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9680325" y="2135067"/>
            <a:ext cx="393971" cy="174215"/>
          </a:xfrm>
          <a:prstGeom prst="rect">
            <a:avLst/>
          </a:prstGeom>
          <a:solidFill>
            <a:schemeClr val="accent1">
              <a:lumMod val="40000"/>
              <a:lumOff val="60000"/>
              <a:alpha val="2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9661288" y="6398455"/>
            <a:ext cx="393971" cy="69661"/>
          </a:xfrm>
          <a:prstGeom prst="rect">
            <a:avLst/>
          </a:prstGeom>
          <a:solidFill>
            <a:schemeClr val="accent1">
              <a:lumMod val="40000"/>
              <a:lumOff val="60000"/>
              <a:alpha val="2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Straight Connector 20"/>
          <p:cNvCxnSpPr/>
          <p:nvPr/>
        </p:nvCxnSpPr>
        <p:spPr>
          <a:xfrm>
            <a:off x="5197626" y="1753743"/>
            <a:ext cx="0" cy="495765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5495798" y="1733867"/>
            <a:ext cx="0" cy="495765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6257799" y="1660983"/>
            <a:ext cx="0" cy="495765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9285920" y="1614603"/>
            <a:ext cx="0" cy="495765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 rot="16200000">
            <a:off x="1502356" y="3816646"/>
            <a:ext cx="41444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Top 50 most variable protein coding genes</a:t>
            </a:r>
            <a:br>
              <a:rPr lang="en-US" dirty="0" smtClean="0"/>
            </a:br>
            <a:r>
              <a:rPr lang="en-US" dirty="0" smtClean="0"/>
              <a:t>(excludes MT proteins)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309716" y="442452"/>
            <a:ext cx="1154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9615375" y="1467204"/>
            <a:ext cx="1366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Intact/degraded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9644923" y="1703809"/>
            <a:ext cx="369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kit</a:t>
            </a:r>
            <a:endParaRPr lang="en-US" sz="1400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4"/>
          <a:srcRect t="76258"/>
          <a:stretch/>
        </p:blipFill>
        <p:spPr>
          <a:xfrm rot="16200000">
            <a:off x="9910215" y="6100164"/>
            <a:ext cx="1040822" cy="152583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0430626" y="5685540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3.5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10430626" y="636386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.75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10481730" y="604249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9748695" y="6034127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Log2(RPKM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243439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slevine</cp:lastModifiedBy>
  <cp:revision>2</cp:revision>
  <dcterms:created xsi:type="dcterms:W3CDTF">2017-09-11T13:25:41Z</dcterms:created>
  <dcterms:modified xsi:type="dcterms:W3CDTF">2018-01-13T14:28:06Z</dcterms:modified>
</cp:coreProperties>
</file>